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  <p:sldId id="26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96" y="1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D5ABD6-0598-E0AB-93A1-088106A6F4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9D1E722-BE49-606D-5FD0-303312AD657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50B352-1956-677B-ACDE-5CE612F489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CB68D-7E09-4547-93F4-A561D5D60508}" type="datetimeFigureOut">
              <a:rPr lang="en-US" smtClean="0"/>
              <a:t>12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D9E4FD-34B9-1D0D-3D3B-78442D3AC8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09E73D-8423-BFF1-9F11-F782027399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692CF-CEC3-459F-97FA-0E7355474B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92628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B8E089-FAC0-39AE-FDD3-30D9AEE0F0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54DE58D-5F5A-D3D1-AA52-81FBB6CB0B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FEE9F8-7469-E74D-1007-66FCFC24BB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CB68D-7E09-4547-93F4-A561D5D60508}" type="datetimeFigureOut">
              <a:rPr lang="en-US" smtClean="0"/>
              <a:t>12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2EAB19-3910-DCEA-C0E4-475C190246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6A4680-9B9C-42EF-CDFD-BF1E74B0E1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692CF-CEC3-459F-97FA-0E7355474B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67032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EDEAFCB-AAC7-95B5-2297-5CA80C8EEFF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1A11615-4B4A-3ECA-DDB0-C1CEBA1695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28D318-CB94-4160-F3FA-310338F2CB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CB68D-7E09-4547-93F4-A561D5D60508}" type="datetimeFigureOut">
              <a:rPr lang="en-US" smtClean="0"/>
              <a:t>12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3FD481-8E5D-CBAD-B3E9-F100A3D194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6BAC4B-F9CA-786B-31C6-8BE2D2927B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692CF-CEC3-459F-97FA-0E7355474B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8615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227295-9D41-2F24-2A36-E79D61710F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3728781-90B1-BDA0-4C74-5ECF6F89181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C3DCEA-0C4F-D593-24B1-447E6E2A2A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CB68D-7E09-4547-93F4-A561D5D60508}" type="datetimeFigureOut">
              <a:rPr lang="en-US" smtClean="0"/>
              <a:t>12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04A5F7-EEB9-08E7-793E-CBF9F22728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87437B-F607-80DB-1ADD-9A93909A42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692CF-CEC3-459F-97FA-0E7355474B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7478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988793-9E80-A925-EDD7-5AB0ADAC56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5663FE-9FB0-4749-D84A-C445EEA82F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051EA8-5BC0-239A-36F6-9A06C31CA3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CB68D-7E09-4547-93F4-A561D5D60508}" type="datetimeFigureOut">
              <a:rPr lang="en-US" smtClean="0"/>
              <a:t>12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031987-2C5A-05D9-20FA-6238FADC9B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021A12-B703-A930-D986-8EAE862612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692CF-CEC3-459F-97FA-0E7355474B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64786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A528D7-0C5C-284C-15C1-86D280F6B5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3E5D18A-3DF4-4057-F3A9-49D94C87C8A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31D75E6-0127-6B1B-FCFB-67DCA04E8C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35717A8-A53C-AD11-22BB-258E6A5A1F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CB68D-7E09-4547-93F4-A561D5D60508}" type="datetimeFigureOut">
              <a:rPr lang="en-US" smtClean="0"/>
              <a:t>12/2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8CB0B7F-95FE-893A-AE32-C61B15CB82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1252C4-72A7-D0D8-1340-C96343711D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692CF-CEC3-459F-97FA-0E7355474B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00424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C6D053-4815-BD45-784F-BDA0A218A0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E9C0B3B-8900-DE0A-6CD4-9EFA56C234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CCF6FF7-AA48-6218-BD78-1653519C0F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B27688D-0C45-F676-C9E2-5B026CF4521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7BABE00-F1C1-B99D-CD63-828435EC681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BD2E2F8-C89D-2B04-4695-E7BFCD0E29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CB68D-7E09-4547-93F4-A561D5D60508}" type="datetimeFigureOut">
              <a:rPr lang="en-US" smtClean="0"/>
              <a:t>12/22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4DDF533-6B74-435D-85EB-B319935D01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B79A236-B105-A148-82D2-6F9F86BDFB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692CF-CEC3-459F-97FA-0E7355474B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5228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897396-04D5-FA43-4851-72159AE102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3CB567E-D3C8-CF5B-639C-CC59AD0189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CB68D-7E09-4547-93F4-A561D5D60508}" type="datetimeFigureOut">
              <a:rPr lang="en-US" smtClean="0"/>
              <a:t>12/22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BC6732E-92E0-3B56-EBE7-EBC1B52300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C022569-1039-FFE3-482E-038712047B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692CF-CEC3-459F-97FA-0E7355474B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5612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EDA3AED-4B83-A947-F886-A6469F2DFB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CB68D-7E09-4547-93F4-A561D5D60508}" type="datetimeFigureOut">
              <a:rPr lang="en-US" smtClean="0"/>
              <a:t>12/22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3750673-B8F0-A085-C238-E8213D4037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9E1E1F2-3360-A8B5-C3C4-CE586F173F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692CF-CEC3-459F-97FA-0E7355474B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76890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1779CC-68F6-AD43-E538-C8C790CFA6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E05589-B131-28CB-CECC-7F6C44220F3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22F4BD3-A65C-D7AB-1A51-1CDF193D35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0D8EB4-9A18-E39F-FB55-63D4FB3BCB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CB68D-7E09-4547-93F4-A561D5D60508}" type="datetimeFigureOut">
              <a:rPr lang="en-US" smtClean="0"/>
              <a:t>12/2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2C759A4-D8AE-7A79-A5A4-BB1333861B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0AAF17-627B-73E9-5988-CDD8CA8260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692CF-CEC3-459F-97FA-0E7355474B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28349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ECAB9E-8C16-9F54-5E44-5A3B8CE1B5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2519C23-27A3-AEBA-472B-57AE427C341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82BE5A5-C6B1-D1A4-BBFE-D27934C3B1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AAB8E72-49CC-2C23-0F0E-34753C35C2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CB68D-7E09-4547-93F4-A561D5D60508}" type="datetimeFigureOut">
              <a:rPr lang="en-US" smtClean="0"/>
              <a:t>12/2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1C855AB-AD99-B493-F72C-55E5EB38B3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BA9D72B-6DFA-F8D6-C6CC-B63007AD90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2692CF-CEC3-459F-97FA-0E7355474B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51498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86877DD-A8F4-6DDB-8879-62242ECFE5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6E4EBF-A4F2-7FC0-902C-C1209B68BE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9F69EA-6105-12DF-3912-F982C6E06D4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A0CB68D-7E09-4547-93F4-A561D5D60508}" type="datetimeFigureOut">
              <a:rPr lang="en-US" smtClean="0"/>
              <a:t>12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1AD064-B621-E7FF-9BEA-682196F9641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25CF13-2CA8-3DF2-C674-0213EB4D7A9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82692CF-CEC3-459F-97FA-0E7355474B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47245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242E427-2CB8-FBCF-A8A3-37F059EC94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38155" y="559861"/>
            <a:ext cx="2384079" cy="2286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29CE4E77-A1B4-BAE1-7B07-3A51BE2A610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0120" y="559861"/>
            <a:ext cx="2384080" cy="22860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5CB9ED0-0352-16E9-3BF5-1A44CC75AA0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43489" y="559861"/>
            <a:ext cx="2345377" cy="2286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68B02EF8-1AA8-793E-B464-A90C0235497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371523" y="559861"/>
            <a:ext cx="2330532" cy="22860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80143375-DBB6-F3DF-FD73-FB1D90B6CC9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751345" y="559861"/>
            <a:ext cx="2330535" cy="22860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10032FF0-A55A-D983-33B0-0AD4E611716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751344" y="3675983"/>
            <a:ext cx="2330535" cy="22860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F46393F0-5648-917E-92D6-E4568E6491D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371523" y="3675983"/>
            <a:ext cx="2330535" cy="22860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84DF8CA8-0BE8-15E7-C5BD-475CC6A6EB7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938155" y="3675983"/>
            <a:ext cx="2384080" cy="22860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DC0EB5DB-622D-07A7-4A8B-226F831B420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543489" y="3675983"/>
            <a:ext cx="2345377" cy="22860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FC4C1372-C553-526E-D50F-D204F944E38D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05862" y="3675983"/>
            <a:ext cx="2384080" cy="228600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4D7DD5C4-5202-3367-89D4-29E503FF9132}"/>
              </a:ext>
            </a:extLst>
          </p:cNvPr>
          <p:cNvSpPr txBox="1"/>
          <p:nvPr/>
        </p:nvSpPr>
        <p:spPr>
          <a:xfrm>
            <a:off x="4936612" y="6215077"/>
            <a:ext cx="23193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l Figure 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A10064D-8C82-2E17-C50D-92EFD16BC96C}"/>
              </a:ext>
            </a:extLst>
          </p:cNvPr>
          <p:cNvSpPr txBox="1"/>
          <p:nvPr/>
        </p:nvSpPr>
        <p:spPr>
          <a:xfrm>
            <a:off x="4894838" y="63982"/>
            <a:ext cx="24273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No CD8+ T cells presen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1A5AD38-85E6-99E6-E74F-3DE38D1AEEEB}"/>
              </a:ext>
            </a:extLst>
          </p:cNvPr>
          <p:cNvSpPr txBox="1"/>
          <p:nvPr/>
        </p:nvSpPr>
        <p:spPr>
          <a:xfrm>
            <a:off x="105862" y="157119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923080D-B51C-6526-645E-D1448DA9A7DE}"/>
              </a:ext>
            </a:extLst>
          </p:cNvPr>
          <p:cNvSpPr txBox="1"/>
          <p:nvPr/>
        </p:nvSpPr>
        <p:spPr>
          <a:xfrm>
            <a:off x="105862" y="3275154"/>
            <a:ext cx="2712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A1DC352-1C76-401D-3293-04B6514CAAC0}"/>
              </a:ext>
            </a:extLst>
          </p:cNvPr>
          <p:cNvSpPr txBox="1"/>
          <p:nvPr/>
        </p:nvSpPr>
        <p:spPr>
          <a:xfrm>
            <a:off x="4953186" y="3180104"/>
            <a:ext cx="22862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D4+ and CD8+ T cells</a:t>
            </a:r>
          </a:p>
        </p:txBody>
      </p:sp>
    </p:spTree>
    <p:extLst>
      <p:ext uri="{BB962C8B-B14F-4D97-AF65-F5344CB8AC3E}">
        <p14:creationId xmlns:p14="http://schemas.microsoft.com/office/powerpoint/2010/main" val="2727384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42EAC53-4C4B-8C03-7362-11811886513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F53A3EA-DC4C-E8FB-DE16-3048EAC3DAD0}"/>
              </a:ext>
            </a:extLst>
          </p:cNvPr>
          <p:cNvSpPr txBox="1"/>
          <p:nvPr/>
        </p:nvSpPr>
        <p:spPr>
          <a:xfrm>
            <a:off x="584200" y="3128201"/>
            <a:ext cx="110236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l Figure 1: Representative flow cytometry plots for suppression assays</a:t>
            </a:r>
          </a:p>
          <a:p>
            <a:r>
              <a:rPr lang="en-US" dirty="0"/>
              <a:t>General gating strategy for all CD8+ suppression assays. Cells are gated on all events </a:t>
            </a:r>
            <a:r>
              <a:rPr lang="en-US" dirty="0">
                <a:sym typeface="Wingdings" panose="05000000000000000000" pitchFamily="2" charset="2"/>
              </a:rPr>
              <a:t> live cells  singlets  CD4+ T cells  CFSE+ CD3+</a:t>
            </a:r>
            <a:r>
              <a:rPr lang="en-US" dirty="0"/>
              <a:t> cells. Representative plots for a non-suppressed population (A) and suppressed population (B).</a:t>
            </a:r>
          </a:p>
        </p:txBody>
      </p:sp>
    </p:spTree>
    <p:extLst>
      <p:ext uri="{BB962C8B-B14F-4D97-AF65-F5344CB8AC3E}">
        <p14:creationId xmlns:p14="http://schemas.microsoft.com/office/powerpoint/2010/main" val="19334617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7</Words>
  <Application>Microsoft Office PowerPoint</Application>
  <PresentationFormat>Widescreen</PresentationFormat>
  <Paragraphs>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Wingdings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ogers, Kai</dc:creator>
  <cp:lastModifiedBy>Rogers, Kai</cp:lastModifiedBy>
  <cp:revision>1</cp:revision>
  <dcterms:created xsi:type="dcterms:W3CDTF">2025-12-22T20:12:56Z</dcterms:created>
  <dcterms:modified xsi:type="dcterms:W3CDTF">2025-12-22T20:13:41Z</dcterms:modified>
</cp:coreProperties>
</file>